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C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65" d="100"/>
          <a:sy n="65" d="100"/>
        </p:scale>
        <p:origin x="9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B7295BD-1837-FD8E-EE59-4D764A373D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3E31C9E-7CE1-4604-8280-08BD2AF3BE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EC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2876B23-4E0C-90AE-6D1E-33EDFFE90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74BEC-13A4-44E5-8ABE-97EB8F7618F1}" type="datetimeFigureOut">
              <a:rPr lang="es-EC" smtClean="0"/>
              <a:t>14/1/2026</a:t>
            </a:fld>
            <a:endParaRPr lang="es-EC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8786D62-7078-B0DD-9321-9B3C8B6D31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CB0077E-9B51-A2FC-5049-224BD526F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8230A-2C2D-4A63-AB25-594BB44BB397}" type="slidenum">
              <a:rPr lang="es-EC" smtClean="0"/>
              <a:t>‹Nº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3591708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AA3F0F3-8900-1BC9-A255-0F3A984F4B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332CCEEC-0E01-C65D-4D59-362CF09BDB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18AD811-AA17-BF56-87BE-72B062AB92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74BEC-13A4-44E5-8ABE-97EB8F7618F1}" type="datetimeFigureOut">
              <a:rPr lang="es-EC" smtClean="0"/>
              <a:t>14/1/2026</a:t>
            </a:fld>
            <a:endParaRPr lang="es-EC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02F4453-E484-69A6-E95A-923AC4CEF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77E7BCC-1E99-5A48-49B4-ABAD0B321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8230A-2C2D-4A63-AB25-594BB44BB397}" type="slidenum">
              <a:rPr lang="es-EC" smtClean="0"/>
              <a:t>‹Nº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3702611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91CE4BF-9428-37D7-7EAA-96516D1A7D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EF1F9DC-36AB-AA13-BCF9-25E235951A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782EFF4-CFBE-C6CD-A738-F5D6784A0C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74BEC-13A4-44E5-8ABE-97EB8F7618F1}" type="datetimeFigureOut">
              <a:rPr lang="es-EC" smtClean="0"/>
              <a:t>14/1/2026</a:t>
            </a:fld>
            <a:endParaRPr lang="es-EC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CAD61D8-30DA-8A4A-DEFF-D461E320A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3F65D47-2F9F-5F3D-7F72-2C2C36F8BC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8230A-2C2D-4A63-AB25-594BB44BB397}" type="slidenum">
              <a:rPr lang="es-EC" smtClean="0"/>
              <a:t>‹Nº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1591665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FF47886-6F17-EC7E-DF90-A9A43E0AB6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0FBF3EF-40DE-6641-99FF-4DC082A03B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F133BD6-02E5-BA4E-519D-48EB393C9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74BEC-13A4-44E5-8ABE-97EB8F7618F1}" type="datetimeFigureOut">
              <a:rPr lang="es-EC" smtClean="0"/>
              <a:t>14/1/2026</a:t>
            </a:fld>
            <a:endParaRPr lang="es-EC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7BEA488-62C3-A0D6-3915-2A983E71F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5363175-A393-C3BA-6382-CA2AEA20D3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8230A-2C2D-4A63-AB25-594BB44BB397}" type="slidenum">
              <a:rPr lang="es-EC" smtClean="0"/>
              <a:t>‹Nº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2207355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4488DD2-95DB-CF8D-0E14-05B87E8E3C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95F588D-CD3C-47EE-5283-273CDE06A8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050A4EE-DE24-4F86-85A4-193E24464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74BEC-13A4-44E5-8ABE-97EB8F7618F1}" type="datetimeFigureOut">
              <a:rPr lang="es-EC" smtClean="0"/>
              <a:t>14/1/2026</a:t>
            </a:fld>
            <a:endParaRPr lang="es-EC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0A9D3EB-B2B3-EAA6-BEC4-03304AE74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11EF34F-54B4-0960-454C-1D529EE7EF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8230A-2C2D-4A63-AB25-594BB44BB397}" type="slidenum">
              <a:rPr lang="es-EC" smtClean="0"/>
              <a:t>‹Nº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175014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8AFD0CE-26A5-888F-1F8D-D566018804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F926EF2-E536-F989-7CCF-C22546EEE5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E4BEA42-C821-E423-7062-FA0E60AD69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B5268E2-A20F-47D0-E201-EACC299CD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74BEC-13A4-44E5-8ABE-97EB8F7618F1}" type="datetimeFigureOut">
              <a:rPr lang="es-EC" smtClean="0"/>
              <a:t>14/1/2026</a:t>
            </a:fld>
            <a:endParaRPr lang="es-EC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9E99569-2D9D-A50B-D0E2-D556245AB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2FCC671-F89F-E1C0-6369-EA26D5A6D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8230A-2C2D-4A63-AB25-594BB44BB397}" type="slidenum">
              <a:rPr lang="es-EC" smtClean="0"/>
              <a:t>‹Nº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1572097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7F08AF-06B4-F812-9490-5F64B68FE4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A6A7BC7-B48B-5F41-D6EE-EFCEB5FE3B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7CA4C70-4FAB-78F0-A0EC-92D6CBB396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90CB7783-274A-E06B-4459-C0D9937AAE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B41F2279-E6A4-E008-8339-5E373D37DB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6046F547-D478-8970-EB8B-76A6D9BEC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74BEC-13A4-44E5-8ABE-97EB8F7618F1}" type="datetimeFigureOut">
              <a:rPr lang="es-EC" smtClean="0"/>
              <a:t>14/1/2026</a:t>
            </a:fld>
            <a:endParaRPr lang="es-EC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54B8D6AF-C175-7AB2-BCDB-AF9688A0E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1E2805D-3D23-FE9B-7ECA-C7243EF43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8230A-2C2D-4A63-AB25-594BB44BB397}" type="slidenum">
              <a:rPr lang="es-EC" smtClean="0"/>
              <a:t>‹Nº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2401549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78E428E-9813-B6E3-481A-D60818816F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F00062B-FC78-921B-097C-073834F91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74BEC-13A4-44E5-8ABE-97EB8F7618F1}" type="datetimeFigureOut">
              <a:rPr lang="es-EC" smtClean="0"/>
              <a:t>14/1/2026</a:t>
            </a:fld>
            <a:endParaRPr lang="es-EC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22921A64-CF7B-B8F5-66B7-90C163584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EA88F30C-5393-3A9D-F1C1-DD57BD707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8230A-2C2D-4A63-AB25-594BB44BB397}" type="slidenum">
              <a:rPr lang="es-EC" smtClean="0"/>
              <a:t>‹Nº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2342291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0C4D096E-7772-4193-B11F-F48B2B9C7A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74BEC-13A4-44E5-8ABE-97EB8F7618F1}" type="datetimeFigureOut">
              <a:rPr lang="es-EC" smtClean="0"/>
              <a:t>14/1/2026</a:t>
            </a:fld>
            <a:endParaRPr lang="es-EC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6102E529-9EAB-CD70-8E53-037AE7F81D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D1577E10-8FB5-DDB2-FF9A-E0DA5C57E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8230A-2C2D-4A63-AB25-594BB44BB397}" type="slidenum">
              <a:rPr lang="es-EC" smtClean="0"/>
              <a:t>‹Nº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1264091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404FD35-32E2-03BC-2599-588D2F0014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5ED7873-C9E5-1E53-F3F3-13A4EBD19C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DB092C8-817C-6522-17B8-DDC131EBC5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9EF5804-EE74-D452-DC30-63F9D406CB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74BEC-13A4-44E5-8ABE-97EB8F7618F1}" type="datetimeFigureOut">
              <a:rPr lang="es-EC" smtClean="0"/>
              <a:t>14/1/2026</a:t>
            </a:fld>
            <a:endParaRPr lang="es-EC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948E0F9-E3BC-2A55-0EEE-F8171B1AB0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BD8BAF2-D6CF-6629-1ED3-0E44EDBA7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8230A-2C2D-4A63-AB25-594BB44BB397}" type="slidenum">
              <a:rPr lang="es-EC" smtClean="0"/>
              <a:t>‹Nº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739493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9CB9F7F-A388-5950-4C9D-4BC72FAC2A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D6444206-0EEC-219E-1E69-39C33EE0AF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C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B2AF584-F31A-FF2D-8CE4-CFBD898C98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607BF21-A8D5-8A59-0728-94123B052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74BEC-13A4-44E5-8ABE-97EB8F7618F1}" type="datetimeFigureOut">
              <a:rPr lang="es-EC" smtClean="0"/>
              <a:t>14/1/2026</a:t>
            </a:fld>
            <a:endParaRPr lang="es-EC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1527CAF-3D04-3213-E471-3450BF903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0EC2B8D-62A9-162B-98EE-911BD0971C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8230A-2C2D-4A63-AB25-594BB44BB397}" type="slidenum">
              <a:rPr lang="es-EC" smtClean="0"/>
              <a:t>‹Nº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2863192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D348AC51-CCFF-7320-08BB-9797FC30D7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65B4057-DB01-8F72-A9A7-7D782ECC0C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764160E-8088-735C-237D-78CB0C63C3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E74BEC-13A4-44E5-8ABE-97EB8F7618F1}" type="datetimeFigureOut">
              <a:rPr lang="es-EC" smtClean="0"/>
              <a:t>14/1/2026</a:t>
            </a:fld>
            <a:endParaRPr lang="es-EC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9ECA825-C0BA-1F1D-BC08-07E613A611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C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50B3DE8-5117-2B43-B5EC-AA2E83274A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758230A-2C2D-4A63-AB25-594BB44BB397}" type="slidenum">
              <a:rPr lang="es-EC" smtClean="0"/>
              <a:t>‹Nº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771713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C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Imagen que contiene exterior, pasto, pila, azul&#10;&#10;El contenido generado por IA puede ser incorrecto.">
            <a:extLst>
              <a:ext uri="{FF2B5EF4-FFF2-40B4-BE49-F238E27FC236}">
                <a16:creationId xmlns:a16="http://schemas.microsoft.com/office/drawing/2014/main" id="{D0151DBA-806C-0796-9F52-9350BC122D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9422" y="524656"/>
            <a:ext cx="3992380" cy="2994286"/>
          </a:xfrm>
          <a:prstGeom prst="rect">
            <a:avLst/>
          </a:prstGeom>
        </p:spPr>
      </p:pic>
      <p:pic>
        <p:nvPicPr>
          <p:cNvPr id="7" name="Imagen 6" descr="Persona en el bosque&#10;&#10;El contenido generado por IA puede ser incorrecto.">
            <a:extLst>
              <a:ext uri="{FF2B5EF4-FFF2-40B4-BE49-F238E27FC236}">
                <a16:creationId xmlns:a16="http://schemas.microsoft.com/office/drawing/2014/main" id="{494DAE55-D973-1D29-2A5C-25EAD23C18B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547" b="15629"/>
          <a:stretch>
            <a:fillRect/>
          </a:stretch>
        </p:blipFill>
        <p:spPr>
          <a:xfrm>
            <a:off x="5053247" y="524656"/>
            <a:ext cx="3518542" cy="2994286"/>
          </a:xfrm>
          <a:prstGeom prst="rect">
            <a:avLst/>
          </a:prstGeom>
        </p:spPr>
      </p:pic>
      <p:pic>
        <p:nvPicPr>
          <p:cNvPr id="9" name="Imagen 8" descr="Un grupo de personas en un río&#10;&#10;El contenido generado por IA puede ser incorrecto.">
            <a:extLst>
              <a:ext uri="{FF2B5EF4-FFF2-40B4-BE49-F238E27FC236}">
                <a16:creationId xmlns:a16="http://schemas.microsoft.com/office/drawing/2014/main" id="{3AD65919-A3A4-B18C-2F8B-C920E71983C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9421" y="3650104"/>
            <a:ext cx="3992381" cy="2994286"/>
          </a:xfrm>
          <a:prstGeom prst="rect">
            <a:avLst/>
          </a:prstGeom>
        </p:spPr>
      </p:pic>
      <p:pic>
        <p:nvPicPr>
          <p:cNvPr id="11" name="Imagen 10" descr="Imagen que contiene exterior, persona, hombre, pasto&#10;&#10;El contenido generado por IA puede ser incorrecto.">
            <a:extLst>
              <a:ext uri="{FF2B5EF4-FFF2-40B4-BE49-F238E27FC236}">
                <a16:creationId xmlns:a16="http://schemas.microsoft.com/office/drawing/2014/main" id="{8843E18C-B891-317D-8939-66DF5DB9E59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180" b="24809"/>
          <a:stretch>
            <a:fillRect/>
          </a:stretch>
        </p:blipFill>
        <p:spPr>
          <a:xfrm>
            <a:off x="5053247" y="3650104"/>
            <a:ext cx="3551058" cy="2994286"/>
          </a:xfrm>
          <a:prstGeom prst="rect">
            <a:avLst/>
          </a:prstGeom>
        </p:spPr>
      </p:pic>
      <p:sp>
        <p:nvSpPr>
          <p:cNvPr id="12" name="CuadroTexto 11">
            <a:extLst>
              <a:ext uri="{FF2B5EF4-FFF2-40B4-BE49-F238E27FC236}">
                <a16:creationId xmlns:a16="http://schemas.microsoft.com/office/drawing/2014/main" id="{E2EFD0F5-1983-4C19-D39A-97F1168B13C6}"/>
              </a:ext>
            </a:extLst>
          </p:cNvPr>
          <p:cNvSpPr txBox="1"/>
          <p:nvPr/>
        </p:nvSpPr>
        <p:spPr>
          <a:xfrm>
            <a:off x="4380967" y="524656"/>
            <a:ext cx="400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>
                <a:solidFill>
                  <a:schemeClr val="bg1"/>
                </a:solidFill>
              </a:rPr>
              <a:t>A</a:t>
            </a:r>
            <a:r>
              <a:rPr lang="es-MX" b="1" dirty="0"/>
              <a:t>.</a:t>
            </a:r>
            <a:endParaRPr lang="es-EC" b="1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0B3D024B-5196-D2C3-0D07-6CEE043B8727}"/>
              </a:ext>
            </a:extLst>
          </p:cNvPr>
          <p:cNvSpPr txBox="1"/>
          <p:nvPr/>
        </p:nvSpPr>
        <p:spPr>
          <a:xfrm>
            <a:off x="8082567" y="524656"/>
            <a:ext cx="400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>
                <a:solidFill>
                  <a:schemeClr val="bg1"/>
                </a:solidFill>
              </a:rPr>
              <a:t>B</a:t>
            </a:r>
            <a:r>
              <a:rPr lang="es-MX" b="1" dirty="0"/>
              <a:t>.</a:t>
            </a:r>
            <a:endParaRPr lang="es-EC" b="1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D2486D3C-A1ED-A75B-15F8-D4EB3BE58467}"/>
              </a:ext>
            </a:extLst>
          </p:cNvPr>
          <p:cNvSpPr txBox="1"/>
          <p:nvPr/>
        </p:nvSpPr>
        <p:spPr>
          <a:xfrm>
            <a:off x="4340719" y="3650104"/>
            <a:ext cx="414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>
                <a:solidFill>
                  <a:schemeClr val="bg1"/>
                </a:solidFill>
              </a:rPr>
              <a:t>C</a:t>
            </a:r>
            <a:r>
              <a:rPr lang="es-MX" b="1" dirty="0"/>
              <a:t>.</a:t>
            </a:r>
            <a:endParaRPr lang="es-EC" b="1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63065466-98B4-329B-9565-670FCF7B103D}"/>
              </a:ext>
            </a:extLst>
          </p:cNvPr>
          <p:cNvSpPr txBox="1"/>
          <p:nvPr/>
        </p:nvSpPr>
        <p:spPr>
          <a:xfrm>
            <a:off x="8213538" y="3650104"/>
            <a:ext cx="414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>
                <a:solidFill>
                  <a:schemeClr val="bg1"/>
                </a:solidFill>
              </a:rPr>
              <a:t>D</a:t>
            </a:r>
            <a:r>
              <a:rPr lang="es-MX" b="1" dirty="0"/>
              <a:t>.</a:t>
            </a:r>
            <a:endParaRPr lang="es-EC" b="1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F29A76C7-E9ED-61F7-0160-538680B83170}"/>
              </a:ext>
            </a:extLst>
          </p:cNvPr>
          <p:cNvSpPr txBox="1"/>
          <p:nvPr/>
        </p:nvSpPr>
        <p:spPr>
          <a:xfrm>
            <a:off x="8952271" y="1047135"/>
            <a:ext cx="2875935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err="1"/>
              <a:t>Supplementary</a:t>
            </a:r>
            <a:r>
              <a:rPr lang="es-MX" dirty="0"/>
              <a:t> Figure 1. Ancestral </a:t>
            </a:r>
            <a:r>
              <a:rPr lang="es-MX" dirty="0" err="1"/>
              <a:t>fishing</a:t>
            </a:r>
            <a:r>
              <a:rPr lang="es-MX" dirty="0"/>
              <a:t> </a:t>
            </a:r>
            <a:r>
              <a:rPr lang="es-MX" dirty="0" err="1"/>
              <a:t>technique</a:t>
            </a:r>
            <a:r>
              <a:rPr lang="es-MX" dirty="0"/>
              <a:t> </a:t>
            </a:r>
            <a:r>
              <a:rPr lang="es-MX" dirty="0" err="1"/>
              <a:t>using</a:t>
            </a:r>
            <a:r>
              <a:rPr lang="es-MX" dirty="0"/>
              <a:t> Barbasco. A. </a:t>
            </a:r>
            <a:r>
              <a:rPr lang="es-MX" dirty="0" err="1"/>
              <a:t>Roots</a:t>
            </a:r>
            <a:r>
              <a:rPr lang="es-MX" dirty="0"/>
              <a:t> of </a:t>
            </a:r>
            <a:r>
              <a:rPr lang="en-US" i="1" dirty="0" err="1"/>
              <a:t>Lonchocarpus</a:t>
            </a:r>
            <a:r>
              <a:rPr lang="en-US" i="1" dirty="0"/>
              <a:t> utilis</a:t>
            </a:r>
            <a:r>
              <a:rPr lang="en-US" dirty="0"/>
              <a:t>. B. A fisherman places the pack of roots in the stream. C. Two fishers enclose </a:t>
            </a:r>
            <a:r>
              <a:rPr lang="en-US" dirty="0" err="1"/>
              <a:t>thesegment</a:t>
            </a:r>
            <a:r>
              <a:rPr lang="en-US" dirty="0"/>
              <a:t> of the stream with gill nets. D. Fish are caught with hand nets. </a:t>
            </a:r>
            <a:endParaRPr lang="es-EC" dirty="0"/>
          </a:p>
        </p:txBody>
      </p:sp>
    </p:spTree>
    <p:extLst>
      <p:ext uri="{BB962C8B-B14F-4D97-AF65-F5344CB8AC3E}">
        <p14:creationId xmlns:p14="http://schemas.microsoft.com/office/powerpoint/2010/main" val="165432878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60</Words>
  <Application>Microsoft Office PowerPoint</Application>
  <PresentationFormat>Panorámica</PresentationFormat>
  <Paragraphs>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abriela Elena Echevarría Díaz</dc:creator>
  <cp:lastModifiedBy>Gabriela Elena Echevarría Díaz</cp:lastModifiedBy>
  <cp:revision>1</cp:revision>
  <dcterms:created xsi:type="dcterms:W3CDTF">2026-01-14T14:01:45Z</dcterms:created>
  <dcterms:modified xsi:type="dcterms:W3CDTF">2026-01-14T14:08:02Z</dcterms:modified>
</cp:coreProperties>
</file>